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9" r:id="rId3"/>
    <p:sldId id="257" r:id="rId4"/>
    <p:sldId id="258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88" d="100"/>
          <a:sy n="88" d="100"/>
        </p:scale>
        <p:origin x="612" y="-9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110C5-0831-40D7-82F0-ACF31247EF22}" type="datetimeFigureOut">
              <a:rPr lang="fr-FR" smtClean="0"/>
              <a:t>05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DC91-0136-465C-8578-6841885F97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2108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110C5-0831-40D7-82F0-ACF31247EF22}" type="datetimeFigureOut">
              <a:rPr lang="fr-FR" smtClean="0"/>
              <a:t>05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DC91-0136-465C-8578-6841885F97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9509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110C5-0831-40D7-82F0-ACF31247EF22}" type="datetimeFigureOut">
              <a:rPr lang="fr-FR" smtClean="0"/>
              <a:t>05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DC91-0136-465C-8578-6841885F97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84363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110C5-0831-40D7-82F0-ACF31247EF22}" type="datetimeFigureOut">
              <a:rPr lang="fr-FR" smtClean="0"/>
              <a:t>05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DC91-0136-465C-8578-6841885F97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58994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110C5-0831-40D7-82F0-ACF31247EF22}" type="datetimeFigureOut">
              <a:rPr lang="fr-FR" smtClean="0"/>
              <a:t>05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DC91-0136-465C-8578-6841885F97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4319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110C5-0831-40D7-82F0-ACF31247EF22}" type="datetimeFigureOut">
              <a:rPr lang="fr-FR" smtClean="0"/>
              <a:t>05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DC91-0136-465C-8578-6841885F97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1078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110C5-0831-40D7-82F0-ACF31247EF22}" type="datetimeFigureOut">
              <a:rPr lang="fr-FR" smtClean="0"/>
              <a:t>05/07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DC91-0136-465C-8578-6841885F97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1751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110C5-0831-40D7-82F0-ACF31247EF22}" type="datetimeFigureOut">
              <a:rPr lang="fr-FR" smtClean="0"/>
              <a:t>05/07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DC91-0136-465C-8578-6841885F97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44308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110C5-0831-40D7-82F0-ACF31247EF22}" type="datetimeFigureOut">
              <a:rPr lang="fr-FR" smtClean="0"/>
              <a:t>05/07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DC91-0136-465C-8578-6841885F97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2869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110C5-0831-40D7-82F0-ACF31247EF22}" type="datetimeFigureOut">
              <a:rPr lang="fr-FR" smtClean="0"/>
              <a:t>05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DC91-0136-465C-8578-6841885F97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23688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110C5-0831-40D7-82F0-ACF31247EF22}" type="datetimeFigureOut">
              <a:rPr lang="fr-FR" smtClean="0"/>
              <a:t>05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DC91-0136-465C-8578-6841885F97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6766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7110C5-0831-40D7-82F0-ACF31247EF22}" type="datetimeFigureOut">
              <a:rPr lang="fr-FR" smtClean="0"/>
              <a:t>05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B8DC91-0136-465C-8578-6841885F97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18258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Tableau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4567750"/>
              </p:ext>
            </p:extLst>
          </p:nvPr>
        </p:nvGraphicFramePr>
        <p:xfrm>
          <a:off x="619025" y="156559"/>
          <a:ext cx="7886700" cy="1949450"/>
        </p:xfrm>
        <a:graphic>
          <a:graphicData uri="http://schemas.openxmlformats.org/drawingml/2006/table">
            <a:tbl>
              <a:tblPr firstRow="1" firstCol="1" bandRow="1"/>
              <a:tblGrid>
                <a:gridCol w="1971675">
                  <a:extLst>
                    <a:ext uri="{9D8B030D-6E8A-4147-A177-3AD203B41FA5}">
                      <a16:colId xmlns:a16="http://schemas.microsoft.com/office/drawing/2014/main" val="3117290938"/>
                    </a:ext>
                  </a:extLst>
                </a:gridCol>
                <a:gridCol w="1971675">
                  <a:extLst>
                    <a:ext uri="{9D8B030D-6E8A-4147-A177-3AD203B41FA5}">
                      <a16:colId xmlns:a16="http://schemas.microsoft.com/office/drawing/2014/main" val="844508691"/>
                    </a:ext>
                  </a:extLst>
                </a:gridCol>
                <a:gridCol w="1971675">
                  <a:extLst>
                    <a:ext uri="{9D8B030D-6E8A-4147-A177-3AD203B41FA5}">
                      <a16:colId xmlns:a16="http://schemas.microsoft.com/office/drawing/2014/main" val="2250389923"/>
                    </a:ext>
                  </a:extLst>
                </a:gridCol>
                <a:gridCol w="1971675">
                  <a:extLst>
                    <a:ext uri="{9D8B030D-6E8A-4147-A177-3AD203B41FA5}">
                      <a16:colId xmlns:a16="http://schemas.microsoft.com/office/drawing/2014/main" val="214482964"/>
                    </a:ext>
                  </a:extLst>
                </a:gridCol>
              </a:tblGrid>
              <a:tr h="252095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fr-FR" sz="12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ntire</a:t>
                      </a:r>
                      <a:r>
                        <a:rPr lang="fr-FR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CST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hapiro-Wilk normality test: 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6837940"/>
                  </a:ext>
                </a:extLst>
              </a:tr>
              <a:tr h="567055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fr-FR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wo-way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fr-FR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nova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: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ide effect : p = 0.008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ime effect : p = 0.0005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teraction Side*Time : p = 0.008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24730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psilesional CST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alesional CST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ost-hoc </a:t>
                      </a:r>
                      <a:r>
                        <a:rPr lang="en-US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idak's</a:t>
                      </a: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sz="12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ultiple </a:t>
                      </a: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mparisons test, p value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7611395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aseline </a:t>
                      </a:r>
                      <a:r>
                        <a:rPr lang="fr-FR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eanFA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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D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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6 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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4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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6  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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4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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 (0.15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39018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fr-FR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ollow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up </a:t>
                      </a:r>
                      <a:r>
                        <a:rPr lang="fr-FR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eanFA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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D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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2 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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4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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5 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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4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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0.001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19032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ost-hoc </a:t>
                      </a:r>
                      <a:r>
                        <a:rPr lang="en-US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idak's</a:t>
                      </a: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multiple comparisons test, p value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0.0001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 (0.15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1344057"/>
                  </a:ext>
                </a:extLst>
              </a:tr>
            </a:tbl>
          </a:graphicData>
        </a:graphic>
      </p:graphicFrame>
      <p:graphicFrame>
        <p:nvGraphicFramePr>
          <p:cNvPr id="14" name="Tableau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1103508"/>
              </p:ext>
            </p:extLst>
          </p:nvPr>
        </p:nvGraphicFramePr>
        <p:xfrm>
          <a:off x="619025" y="2107582"/>
          <a:ext cx="7886700" cy="1949450"/>
        </p:xfrm>
        <a:graphic>
          <a:graphicData uri="http://schemas.openxmlformats.org/drawingml/2006/table">
            <a:tbl>
              <a:tblPr firstRow="1" firstCol="1" bandRow="1"/>
              <a:tblGrid>
                <a:gridCol w="1971675">
                  <a:extLst>
                    <a:ext uri="{9D8B030D-6E8A-4147-A177-3AD203B41FA5}">
                      <a16:colId xmlns:a16="http://schemas.microsoft.com/office/drawing/2014/main" val="3748027228"/>
                    </a:ext>
                  </a:extLst>
                </a:gridCol>
                <a:gridCol w="1971675">
                  <a:extLst>
                    <a:ext uri="{9D8B030D-6E8A-4147-A177-3AD203B41FA5}">
                      <a16:colId xmlns:a16="http://schemas.microsoft.com/office/drawing/2014/main" val="997333976"/>
                    </a:ext>
                  </a:extLst>
                </a:gridCol>
                <a:gridCol w="1971675">
                  <a:extLst>
                    <a:ext uri="{9D8B030D-6E8A-4147-A177-3AD203B41FA5}">
                      <a16:colId xmlns:a16="http://schemas.microsoft.com/office/drawing/2014/main" val="694977230"/>
                    </a:ext>
                  </a:extLst>
                </a:gridCol>
                <a:gridCol w="1971675">
                  <a:extLst>
                    <a:ext uri="{9D8B030D-6E8A-4147-A177-3AD203B41FA5}">
                      <a16:colId xmlns:a16="http://schemas.microsoft.com/office/drawing/2014/main" val="2532356083"/>
                    </a:ext>
                  </a:extLst>
                </a:gridCol>
              </a:tblGrid>
              <a:tr h="252095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fr-FR" sz="12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ntire</a:t>
                      </a:r>
                      <a:r>
                        <a:rPr lang="fr-FR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CST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hapiro-Wilk normality test: 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87943288"/>
                  </a:ext>
                </a:extLst>
              </a:tr>
              <a:tr h="567055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fr-FR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wo-way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fr-FR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nova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: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ide effect : p = 0.008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ime effect : p = 0.0005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teraction </a:t>
                      </a:r>
                      <a:r>
                        <a:rPr lang="fr-FR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ide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*Time : p = 0.008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81181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psilesional CST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alesional CST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87313" indent="0"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ost-hoc </a:t>
                      </a:r>
                      <a:r>
                        <a:rPr lang="en-US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idak's</a:t>
                      </a: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multiple comparisons test, p value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580610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aseline </a:t>
                      </a:r>
                      <a:r>
                        <a:rPr lang="fr-FR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eanFA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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D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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6 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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4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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6  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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4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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 (0.15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8436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fr-FR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ollow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up </a:t>
                      </a:r>
                      <a:r>
                        <a:rPr lang="fr-FR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eanFA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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D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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2 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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4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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5 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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4</a:t>
                      </a: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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0.001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22380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ost-hoc </a:t>
                      </a:r>
                      <a:r>
                        <a:rPr lang="en-US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idak's</a:t>
                      </a: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multiple comparisons test, p value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0.0001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 (0.15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1292316"/>
                  </a:ext>
                </a:extLst>
              </a:tr>
            </a:tbl>
          </a:graphicData>
        </a:graphic>
      </p:graphicFrame>
      <p:graphicFrame>
        <p:nvGraphicFramePr>
          <p:cNvPr id="16" name="Tableau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4387660"/>
              </p:ext>
            </p:extLst>
          </p:nvPr>
        </p:nvGraphicFramePr>
        <p:xfrm>
          <a:off x="619025" y="4059253"/>
          <a:ext cx="7886700" cy="1982470"/>
        </p:xfrm>
        <a:graphic>
          <a:graphicData uri="http://schemas.openxmlformats.org/drawingml/2006/table">
            <a:tbl>
              <a:tblPr firstRow="1" firstCol="1" bandRow="1"/>
              <a:tblGrid>
                <a:gridCol w="1979032">
                  <a:extLst>
                    <a:ext uri="{9D8B030D-6E8A-4147-A177-3AD203B41FA5}">
                      <a16:colId xmlns:a16="http://schemas.microsoft.com/office/drawing/2014/main" val="879262123"/>
                    </a:ext>
                  </a:extLst>
                </a:gridCol>
                <a:gridCol w="1959429">
                  <a:extLst>
                    <a:ext uri="{9D8B030D-6E8A-4147-A177-3AD203B41FA5}">
                      <a16:colId xmlns:a16="http://schemas.microsoft.com/office/drawing/2014/main" val="3090516304"/>
                    </a:ext>
                  </a:extLst>
                </a:gridCol>
                <a:gridCol w="1981200">
                  <a:extLst>
                    <a:ext uri="{9D8B030D-6E8A-4147-A177-3AD203B41FA5}">
                      <a16:colId xmlns:a16="http://schemas.microsoft.com/office/drawing/2014/main" val="3514691341"/>
                    </a:ext>
                  </a:extLst>
                </a:gridCol>
                <a:gridCol w="1967039">
                  <a:extLst>
                    <a:ext uri="{9D8B030D-6E8A-4147-A177-3AD203B41FA5}">
                      <a16:colId xmlns:a16="http://schemas.microsoft.com/office/drawing/2014/main" val="2106227314"/>
                    </a:ext>
                  </a:extLst>
                </a:gridCol>
              </a:tblGrid>
              <a:tr h="252095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fr-FR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R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hapiro-Wilk normality test: 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8677706"/>
                  </a:ext>
                </a:extLst>
              </a:tr>
              <a:tr h="567055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fr-FR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wo-way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fr-FR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nova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: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ide effect : p &lt; 0,0001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ime effect : 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teraction Side*Time : 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812053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psilesional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CR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alesional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CR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ost-hoc </a:t>
                      </a:r>
                      <a:r>
                        <a:rPr lang="en-US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idak's</a:t>
                      </a: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multiple comparisons test, </a:t>
                      </a:r>
                      <a:r>
                        <a:rPr lang="en-US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value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0982618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aseline </a:t>
                      </a:r>
                      <a:r>
                        <a:rPr lang="fr-FR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eanFA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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D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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31 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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7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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36  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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5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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0.0001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0044820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ollow-up </a:t>
                      </a:r>
                      <a:r>
                        <a:rPr lang="en-US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eanFA</a:t>
                      </a: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</a:t>
                      </a: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D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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30 [0.08]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36 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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5</a:t>
                      </a: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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&lt;0.0001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80263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0"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ost-hoc </a:t>
                      </a:r>
                      <a:r>
                        <a:rPr lang="en-US" sz="12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idak's</a:t>
                      </a: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multiple comparisons test, p value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 (0.09)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 (0.99)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8618301"/>
                  </a:ext>
                </a:extLst>
              </a:tr>
            </a:tbl>
          </a:graphicData>
        </a:graphic>
      </p:graphicFrame>
      <p:sp>
        <p:nvSpPr>
          <p:cNvPr id="17" name="Rectangle 16"/>
          <p:cNvSpPr/>
          <p:nvPr/>
        </p:nvSpPr>
        <p:spPr>
          <a:xfrm>
            <a:off x="619025" y="6045200"/>
            <a:ext cx="78867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sz="1200" i="1" dirty="0" err="1">
                <a:ea typeface="Calibri" panose="020F0502020204030204" pitchFamily="34" charset="0"/>
                <a:cs typeface="Arial" panose="020B0604020202020204" pitchFamily="34" charset="0"/>
              </a:rPr>
              <a:t>Suppl</a:t>
            </a:r>
            <a:r>
              <a:rPr lang="en-US" sz="1200" i="1" dirty="0">
                <a:ea typeface="Calibri" panose="020F0502020204030204" pitchFamily="34" charset="0"/>
                <a:cs typeface="Arial" panose="020B0604020202020204" pitchFamily="34" charset="0"/>
              </a:rPr>
              <a:t> Table 1: Evolution of </a:t>
            </a:r>
            <a:r>
              <a:rPr lang="en-US" sz="1200" i="1" dirty="0" err="1">
                <a:ea typeface="Calibri" panose="020F0502020204030204" pitchFamily="34" charset="0"/>
                <a:cs typeface="Arial" panose="020B0604020202020204" pitchFamily="34" charset="0"/>
              </a:rPr>
              <a:t>meanFA</a:t>
            </a:r>
            <a:r>
              <a:rPr lang="en-US" sz="1200" i="1" dirty="0">
                <a:ea typeface="Calibri" panose="020F0502020204030204" pitchFamily="34" charset="0"/>
                <a:cs typeface="Arial" panose="020B0604020202020204" pitchFamily="34" charset="0"/>
              </a:rPr>
              <a:t> (entire CST, PLIC and CR) between </a:t>
            </a:r>
            <a:r>
              <a:rPr lang="en-US" sz="1200" i="1" dirty="0" err="1">
                <a:ea typeface="Calibri" panose="020F0502020204030204" pitchFamily="34" charset="0"/>
                <a:cs typeface="Arial" panose="020B0604020202020204" pitchFamily="34" charset="0"/>
              </a:rPr>
              <a:t>ipsi</a:t>
            </a:r>
            <a:r>
              <a:rPr lang="en-US" sz="1200" i="1" dirty="0">
                <a:ea typeface="Calibri" panose="020F0502020204030204" pitchFamily="34" charset="0"/>
                <a:cs typeface="Arial" panose="020B0604020202020204" pitchFamily="34" charset="0"/>
              </a:rPr>
              <a:t>- and </a:t>
            </a:r>
            <a:r>
              <a:rPr lang="en-US" sz="1200" i="1" dirty="0" err="1">
                <a:ea typeface="Calibri" panose="020F0502020204030204" pitchFamily="34" charset="0"/>
                <a:cs typeface="Arial" panose="020B0604020202020204" pitchFamily="34" charset="0"/>
              </a:rPr>
              <a:t>contralesional</a:t>
            </a:r>
            <a:r>
              <a:rPr lang="en-US" sz="1200" i="1" dirty="0">
                <a:ea typeface="Calibri" panose="020F0502020204030204" pitchFamily="34" charset="0"/>
                <a:cs typeface="Arial" panose="020B0604020202020204" pitchFamily="34" charset="0"/>
              </a:rPr>
              <a:t> side from the baseline and at follow-up. SD = standard deviation</a:t>
            </a:r>
            <a:r>
              <a:rPr lang="en-US" sz="1200" i="1" dirty="0" smtClean="0">
                <a:ea typeface="Calibri" panose="020F0502020204030204" pitchFamily="34" charset="0"/>
                <a:cs typeface="Arial" panose="020B0604020202020204" pitchFamily="34" charset="0"/>
              </a:rPr>
              <a:t>. ns: non-significant.</a:t>
            </a:r>
            <a:endParaRPr lang="fr-FR" sz="1200" dirty="0"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0"/>
              </a:spcAft>
            </a:pPr>
            <a:r>
              <a:rPr lang="en-US" sz="1200" b="1" dirty="0">
                <a:solidFill>
                  <a:srgbClr val="222222"/>
                </a:solidFill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fr-FR" sz="1200" dirty="0"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00057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au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5676843"/>
              </p:ext>
            </p:extLst>
          </p:nvPr>
        </p:nvGraphicFramePr>
        <p:xfrm>
          <a:off x="2174557" y="3552824"/>
          <a:ext cx="4794885" cy="896939"/>
        </p:xfrm>
        <a:graphic>
          <a:graphicData uri="http://schemas.openxmlformats.org/drawingml/2006/table">
            <a:tbl>
              <a:tblPr firstRow="1" firstCol="1" bandRow="1"/>
              <a:tblGrid>
                <a:gridCol w="958850">
                  <a:extLst>
                    <a:ext uri="{9D8B030D-6E8A-4147-A177-3AD203B41FA5}">
                      <a16:colId xmlns:a16="http://schemas.microsoft.com/office/drawing/2014/main" val="1565090518"/>
                    </a:ext>
                  </a:extLst>
                </a:gridCol>
                <a:gridCol w="958850">
                  <a:extLst>
                    <a:ext uri="{9D8B030D-6E8A-4147-A177-3AD203B41FA5}">
                      <a16:colId xmlns:a16="http://schemas.microsoft.com/office/drawing/2014/main" val="3412127390"/>
                    </a:ext>
                  </a:extLst>
                </a:gridCol>
                <a:gridCol w="958850">
                  <a:extLst>
                    <a:ext uri="{9D8B030D-6E8A-4147-A177-3AD203B41FA5}">
                      <a16:colId xmlns:a16="http://schemas.microsoft.com/office/drawing/2014/main" val="841484893"/>
                    </a:ext>
                  </a:extLst>
                </a:gridCol>
                <a:gridCol w="958850">
                  <a:extLst>
                    <a:ext uri="{9D8B030D-6E8A-4147-A177-3AD203B41FA5}">
                      <a16:colId xmlns:a16="http://schemas.microsoft.com/office/drawing/2014/main" val="947811462"/>
                    </a:ext>
                  </a:extLst>
                </a:gridCol>
                <a:gridCol w="959485">
                  <a:extLst>
                    <a:ext uri="{9D8B030D-6E8A-4147-A177-3AD203B41FA5}">
                      <a16:colId xmlns:a16="http://schemas.microsoft.com/office/drawing/2014/main" val="16295294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ST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psilesional</a:t>
                      </a: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at baseline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tralesional</a:t>
                      </a: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at baseline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psilesional</a:t>
                      </a: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at follow-up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tralesional</a:t>
                      </a: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at follow-up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38472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D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78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0.06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80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0.06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82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0.06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81 ± 0.06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6386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33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0.11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37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0.08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35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0.08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37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0.08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03914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D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1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0.07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2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0.07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6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0.07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4 </a:t>
                      </a: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0.06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6367653"/>
                  </a:ext>
                </a:extLst>
              </a:tr>
            </a:tbl>
          </a:graphicData>
        </a:graphic>
      </p:graphicFrame>
      <p:sp>
        <p:nvSpPr>
          <p:cNvPr id="8" name="ZoneTexte 7"/>
          <p:cNvSpPr txBox="1"/>
          <p:nvPr/>
        </p:nvSpPr>
        <p:spPr>
          <a:xfrm>
            <a:off x="2420090" y="4555066"/>
            <a:ext cx="38364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 err="1" smtClean="0"/>
              <a:t>Suppl</a:t>
            </a:r>
            <a:r>
              <a:rPr lang="fr-FR" sz="1200" i="1" dirty="0" smtClean="0"/>
              <a:t> </a:t>
            </a:r>
            <a:r>
              <a:rPr lang="fr-FR" sz="1200" i="1" dirty="0" smtClean="0"/>
              <a:t>Table 2: </a:t>
            </a:r>
            <a:r>
              <a:rPr lang="fr-FR" sz="1200" i="1" dirty="0" err="1" smtClean="0"/>
              <a:t>mean</a:t>
            </a:r>
            <a:r>
              <a:rPr lang="fr-FR" sz="1200" i="1" dirty="0" smtClean="0"/>
              <a:t>, axial, and radial </a:t>
            </a:r>
            <a:r>
              <a:rPr lang="fr-FR" sz="1200" i="1" dirty="0" err="1" smtClean="0"/>
              <a:t>diffusivity</a:t>
            </a:r>
            <a:r>
              <a:rPr lang="fr-FR" sz="1200" i="1" dirty="0" smtClean="0"/>
              <a:t> of the CST </a:t>
            </a:r>
            <a:endParaRPr lang="fr-FR" sz="1200" i="1" dirty="0"/>
          </a:p>
        </p:txBody>
      </p:sp>
    </p:spTree>
    <p:extLst>
      <p:ext uri="{BB962C8B-B14F-4D97-AF65-F5344CB8AC3E}">
        <p14:creationId xmlns:p14="http://schemas.microsoft.com/office/powerpoint/2010/main" val="3303744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au 4"/>
          <p:cNvGraphicFramePr>
            <a:graphicFrameLocks noGrp="1"/>
          </p:cNvGraphicFramePr>
          <p:nvPr/>
        </p:nvGraphicFramePr>
        <p:xfrm>
          <a:off x="1658155" y="2104549"/>
          <a:ext cx="5827690" cy="3793490"/>
        </p:xfrm>
        <a:graphic>
          <a:graphicData uri="http://schemas.openxmlformats.org/drawingml/2006/table">
            <a:tbl>
              <a:tblPr firstRow="1" firstCol="1" bandRow="1"/>
              <a:tblGrid>
                <a:gridCol w="1887220">
                  <a:extLst>
                    <a:ext uri="{9D8B030D-6E8A-4147-A177-3AD203B41FA5}">
                      <a16:colId xmlns:a16="http://schemas.microsoft.com/office/drawing/2014/main" val="3530822622"/>
                    </a:ext>
                  </a:extLst>
                </a:gridCol>
                <a:gridCol w="269875">
                  <a:extLst>
                    <a:ext uri="{9D8B030D-6E8A-4147-A177-3AD203B41FA5}">
                      <a16:colId xmlns:a16="http://schemas.microsoft.com/office/drawing/2014/main" val="3553153853"/>
                    </a:ext>
                  </a:extLst>
                </a:gridCol>
                <a:gridCol w="127930">
                  <a:extLst>
                    <a:ext uri="{9D8B030D-6E8A-4147-A177-3AD203B41FA5}">
                      <a16:colId xmlns:a16="http://schemas.microsoft.com/office/drawing/2014/main" val="772043213"/>
                    </a:ext>
                  </a:extLst>
                </a:gridCol>
                <a:gridCol w="1537970">
                  <a:extLst>
                    <a:ext uri="{9D8B030D-6E8A-4147-A177-3AD203B41FA5}">
                      <a16:colId xmlns:a16="http://schemas.microsoft.com/office/drawing/2014/main" val="3593407309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1626166665"/>
                    </a:ext>
                  </a:extLst>
                </a:gridCol>
                <a:gridCol w="1128395">
                  <a:extLst>
                    <a:ext uri="{9D8B030D-6E8A-4147-A177-3AD203B41FA5}">
                      <a16:colId xmlns:a16="http://schemas.microsoft.com/office/drawing/2014/main" val="3693556685"/>
                    </a:ext>
                  </a:extLst>
                </a:gridCol>
              </a:tblGrid>
              <a:tr h="50419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ine Peg Hole test at follow-up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 PLIC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 CR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 Po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609915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oderate deficit (&gt;29sec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42 [0.06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24 [0.07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35 [0.10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9082373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ild deficit (&lt;30 sec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2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 [0.08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33 [0.06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39 [0.09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389796"/>
                  </a:ext>
                </a:extLst>
              </a:tr>
              <a:tr h="539750">
                <a:tc gridSpan="6"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hapiro-Wilk normality test: 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wo-way Anova : Group effect : p = 0.001 ; Area effect : p &lt; 0.0001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teraction Group*Area : 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3659181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ost-hoc : t test, p value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44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0045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 (0.46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2465358"/>
                  </a:ext>
                </a:extLst>
              </a:tr>
              <a:tr h="50419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ynamometer at </a:t>
                      </a: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ollow-up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 PLIC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 CR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 Po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8564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oderate deficit (&lt;29 kg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5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45 [0.08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28 [0.08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35 [0.10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7611912"/>
                  </a:ext>
                </a:extLst>
              </a:tr>
              <a:tr h="28321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ild deficit (&gt;30 kg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1 [0.06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33 [0.05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41 [0.07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4299171"/>
                  </a:ext>
                </a:extLst>
              </a:tr>
              <a:tr h="252095">
                <a:tc gridSpan="6"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hapiro-Wilk normality test: 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wo-way Anova : Group effect : p = 0.02 ; Area effect : p &lt; 0.0001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teraction Group*Area : 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58884844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marL="457200"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ost-hoc : t test, p value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 (0.14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 (0.14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 (0.14)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1976831"/>
                  </a:ext>
                </a:extLst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1582057" y="6023429"/>
            <a:ext cx="590378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able </a:t>
            </a:r>
            <a:r>
              <a:rPr lang="fr-FR" sz="1200" i="1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: 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an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FA and SD of the 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ifferent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OIs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osterior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imb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f the 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ternal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apsule, corona 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adiata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ons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at 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llow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up as a 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unction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f the 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linical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everity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f the 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ficit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ssessed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by the 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ine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g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Hole test and the 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ynamometer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n=</a:t>
            </a:r>
            <a:r>
              <a:rPr lang="fr-FR" sz="1200" i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umber</a:t>
            </a:r>
            <a:r>
              <a:rPr lang="fr-FR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f patients. 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s: non-significant</a:t>
            </a:r>
            <a:endParaRPr lang="fr-F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88004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au 4"/>
          <p:cNvGraphicFramePr>
            <a:graphicFrameLocks noGrp="1"/>
          </p:cNvGraphicFramePr>
          <p:nvPr/>
        </p:nvGraphicFramePr>
        <p:xfrm>
          <a:off x="1582102" y="2092166"/>
          <a:ext cx="5979795" cy="3818255"/>
        </p:xfrm>
        <a:graphic>
          <a:graphicData uri="http://schemas.openxmlformats.org/drawingml/2006/table">
            <a:tbl>
              <a:tblPr firstRow="1" firstCol="1" bandRow="1"/>
              <a:tblGrid>
                <a:gridCol w="647700">
                  <a:extLst>
                    <a:ext uri="{9D8B030D-6E8A-4147-A177-3AD203B41FA5}">
                      <a16:colId xmlns:a16="http://schemas.microsoft.com/office/drawing/2014/main" val="616696311"/>
                    </a:ext>
                  </a:extLst>
                </a:gridCol>
                <a:gridCol w="292100">
                  <a:extLst>
                    <a:ext uri="{9D8B030D-6E8A-4147-A177-3AD203B41FA5}">
                      <a16:colId xmlns:a16="http://schemas.microsoft.com/office/drawing/2014/main" val="218843901"/>
                    </a:ext>
                  </a:extLst>
                </a:gridCol>
                <a:gridCol w="756285">
                  <a:extLst>
                    <a:ext uri="{9D8B030D-6E8A-4147-A177-3AD203B41FA5}">
                      <a16:colId xmlns:a16="http://schemas.microsoft.com/office/drawing/2014/main" val="1402696732"/>
                    </a:ext>
                  </a:extLst>
                </a:gridCol>
                <a:gridCol w="828040">
                  <a:extLst>
                    <a:ext uri="{9D8B030D-6E8A-4147-A177-3AD203B41FA5}">
                      <a16:colId xmlns:a16="http://schemas.microsoft.com/office/drawing/2014/main" val="3723144336"/>
                    </a:ext>
                  </a:extLst>
                </a:gridCol>
                <a:gridCol w="575945">
                  <a:extLst>
                    <a:ext uri="{9D8B030D-6E8A-4147-A177-3AD203B41FA5}">
                      <a16:colId xmlns:a16="http://schemas.microsoft.com/office/drawing/2014/main" val="2878468430"/>
                    </a:ext>
                  </a:extLst>
                </a:gridCol>
                <a:gridCol w="575945">
                  <a:extLst>
                    <a:ext uri="{9D8B030D-6E8A-4147-A177-3AD203B41FA5}">
                      <a16:colId xmlns:a16="http://schemas.microsoft.com/office/drawing/2014/main" val="788263263"/>
                    </a:ext>
                  </a:extLst>
                </a:gridCol>
                <a:gridCol w="575945">
                  <a:extLst>
                    <a:ext uri="{9D8B030D-6E8A-4147-A177-3AD203B41FA5}">
                      <a16:colId xmlns:a16="http://schemas.microsoft.com/office/drawing/2014/main" val="1692980237"/>
                    </a:ext>
                  </a:extLst>
                </a:gridCol>
                <a:gridCol w="575945">
                  <a:extLst>
                    <a:ext uri="{9D8B030D-6E8A-4147-A177-3AD203B41FA5}">
                      <a16:colId xmlns:a16="http://schemas.microsoft.com/office/drawing/2014/main" val="315417152"/>
                    </a:ext>
                  </a:extLst>
                </a:gridCol>
                <a:gridCol w="575945">
                  <a:extLst>
                    <a:ext uri="{9D8B030D-6E8A-4147-A177-3AD203B41FA5}">
                      <a16:colId xmlns:a16="http://schemas.microsoft.com/office/drawing/2014/main" val="3366698634"/>
                    </a:ext>
                  </a:extLst>
                </a:gridCol>
                <a:gridCol w="575945">
                  <a:extLst>
                    <a:ext uri="{9D8B030D-6E8A-4147-A177-3AD203B41FA5}">
                      <a16:colId xmlns:a16="http://schemas.microsoft.com/office/drawing/2014/main" val="4095460177"/>
                    </a:ext>
                  </a:extLst>
                </a:gridCol>
              </a:tblGrid>
              <a:tr h="549275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aselineNIHS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ollow-up NIHS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ase-line NPHT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ollow-up NPH 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ase-line </a:t>
                      </a:r>
                      <a:r>
                        <a:rPr lang="fr-FR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YN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ollow-up </a:t>
                      </a:r>
                      <a:r>
                        <a:rPr lang="fr-FR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YN 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ase-line </a:t>
                      </a:r>
                      <a:r>
                        <a:rPr lang="fr-FR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TT 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ollow-up </a:t>
                      </a:r>
                      <a:r>
                        <a:rPr lang="fr-FR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TT 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8470984"/>
                  </a:ext>
                </a:extLst>
              </a:tr>
              <a:tr h="252095">
                <a:tc gridSpan="2">
                  <a:txBody>
                    <a:bodyPr/>
                    <a:lstStyle/>
                    <a:p>
                      <a:pPr marL="4572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wo-way Anova :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4572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roup effect: 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4572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ime effect: p &lt; 10</a:t>
                      </a:r>
                      <a:r>
                        <a:rPr lang="en-US" sz="1200" baseline="30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4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teraction Group*Time : 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4572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roup effect: 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4572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ime effect: p &lt; 10</a:t>
                      </a:r>
                      <a:r>
                        <a:rPr lang="en-US" sz="900" baseline="30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3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teraction Group*Time : 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4572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roup effect: 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4572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ime effect: p &lt; 10</a:t>
                      </a:r>
                      <a:r>
                        <a:rPr lang="en-US" sz="900" baseline="30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2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teraction Group*Time : 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4572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roup effect: 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4572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ime effect: p &lt; 10</a:t>
                      </a:r>
                      <a:r>
                        <a:rPr lang="en-US" sz="900" baseline="30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4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teraction Group*Time : 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78225496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o aMF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.57 [0.8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14 [0.38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5 [31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0 [5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8 [15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1 [15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2 [32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0 [39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83987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MF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4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.21 [1.84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0 [0.75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6 [36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2 [13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8 [13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5 [11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1 [37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3 [39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9011090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ost-hoc : Sidak's multiple comparisons test, p value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s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2630332"/>
                  </a:ext>
                </a:extLst>
              </a:tr>
            </a:tbl>
          </a:graphicData>
        </a:graphic>
      </p:graphicFrame>
      <p:sp>
        <p:nvSpPr>
          <p:cNvPr id="7" name="Rectangle 6"/>
          <p:cNvSpPr/>
          <p:nvPr/>
        </p:nvSpPr>
        <p:spPr>
          <a:xfrm>
            <a:off x="1509485" y="6027003"/>
            <a:ext cx="605241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sz="1200" i="1" dirty="0" err="1">
                <a:solidFill>
                  <a:srgbClr val="222222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</a:t>
            </a:r>
            <a:r>
              <a:rPr lang="en-US" sz="1200" i="1" dirty="0">
                <a:solidFill>
                  <a:srgbClr val="222222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able 4: Clinical assessment in terms of the presence of alternate motor fibers (</a:t>
            </a:r>
            <a:r>
              <a:rPr lang="en-US" sz="1200" i="1" dirty="0" err="1">
                <a:solidFill>
                  <a:srgbClr val="222222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MF</a:t>
            </a:r>
            <a:r>
              <a:rPr lang="en-US" sz="1200" i="1" dirty="0">
                <a:solidFill>
                  <a:srgbClr val="222222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or not (no </a:t>
            </a:r>
            <a:r>
              <a:rPr lang="en-US" sz="1200" i="1" dirty="0" err="1">
                <a:solidFill>
                  <a:srgbClr val="222222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MF</a:t>
            </a:r>
            <a:r>
              <a:rPr lang="en-US" sz="1200" i="1" dirty="0">
                <a:solidFill>
                  <a:srgbClr val="222222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at baseline and follow-up. NPH = Nine-Peg-Hole test, DYN = Dynamometer, HTT=Hand tapping test. n=number of patients.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ns: non-significant.</a:t>
            </a:r>
            <a:endParaRPr lang="fr-FR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48103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65708"/>
            <a:ext cx="9144000" cy="1400316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462589" y="2917149"/>
            <a:ext cx="455506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i="1" dirty="0" err="1" smtClean="0"/>
              <a:t>Suppl</a:t>
            </a:r>
            <a:r>
              <a:rPr lang="fr-FR" sz="1200" i="1" dirty="0" smtClean="0"/>
              <a:t> </a:t>
            </a:r>
            <a:r>
              <a:rPr lang="fr-FR" sz="1200" i="1" dirty="0" smtClean="0"/>
              <a:t>figure 1: </a:t>
            </a:r>
            <a:r>
              <a:rPr lang="fr-FR" sz="1200" i="1" dirty="0" err="1" smtClean="0"/>
              <a:t>reticulospinal</a:t>
            </a:r>
            <a:r>
              <a:rPr lang="fr-FR" sz="1200" i="1" dirty="0" smtClean="0"/>
              <a:t> tract </a:t>
            </a:r>
            <a:r>
              <a:rPr lang="fr-FR" sz="1200" i="1" dirty="0" err="1" smtClean="0"/>
              <a:t>template</a:t>
            </a:r>
            <a:r>
              <a:rPr lang="fr-FR" sz="1200" i="1" dirty="0" smtClean="0"/>
              <a:t> </a:t>
            </a:r>
            <a:endParaRPr lang="fr-FR" sz="1200" i="1" dirty="0"/>
          </a:p>
        </p:txBody>
      </p:sp>
    </p:spTree>
    <p:extLst>
      <p:ext uri="{BB962C8B-B14F-4D97-AF65-F5344CB8AC3E}">
        <p14:creationId xmlns:p14="http://schemas.microsoft.com/office/powerpoint/2010/main" val="220003161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7</TotalTime>
  <Words>851</Words>
  <Application>Microsoft Office PowerPoint</Application>
  <PresentationFormat>Affichage à l'écran (4:3)</PresentationFormat>
  <Paragraphs>194</Paragraphs>
  <Slides>5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Symbol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INSER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sabelle Loubinoux</dc:creator>
  <cp:lastModifiedBy>Isabelle Loubinoux</cp:lastModifiedBy>
  <cp:revision>8</cp:revision>
  <dcterms:created xsi:type="dcterms:W3CDTF">2023-03-06T18:50:52Z</dcterms:created>
  <dcterms:modified xsi:type="dcterms:W3CDTF">2024-07-05T19:31:07Z</dcterms:modified>
</cp:coreProperties>
</file>